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1BF4B-A88F-425D-8EB4-733A817772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3EDD28-54C3-42DC-BD70-87EFD8687E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9D4D7A-DB99-4F75-B80E-A2EAFAAE90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AC1C62-D29A-4C76-8E54-A7B9F644DB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31885A-E835-4D8D-BBA3-1F496C910C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440E8B-7105-4402-8F6A-24B811A720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87116F-DF0D-4FB5-B547-137B087045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7B8F5-6FEB-473A-86F2-896588B38D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944C4B-1758-49CD-935B-6CC574DFB3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EC64A-7801-499B-9168-433E8073A9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5AA0C-A02C-4294-B411-92CD2CCCE1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8CA73-FCC0-460B-926B-E81F756D76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5032BD-91F5-465A-B87C-FA42A1C0B7A6}" type="slidenum">
              <a:rPr b="0" lang="pt-B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" descr=""/>
          <p:cNvPicPr/>
          <p:nvPr/>
        </p:nvPicPr>
        <p:blipFill>
          <a:blip r:embed="rId1"/>
          <a:stretch/>
        </p:blipFill>
        <p:spPr>
          <a:xfrm>
            <a:off x="1428840" y="108000"/>
            <a:ext cx="3362400" cy="3038400"/>
          </a:xfrm>
          <a:prstGeom prst="rect">
            <a:avLst/>
          </a:prstGeom>
          <a:ln w="0">
            <a:noFill/>
          </a:ln>
        </p:spPr>
      </p:pic>
      <p:sp>
        <p:nvSpPr>
          <p:cNvPr id="42" name="CaixaDeTexto 10"/>
          <p:cNvSpPr/>
          <p:nvPr/>
        </p:nvSpPr>
        <p:spPr>
          <a:xfrm>
            <a:off x="1793880" y="109440"/>
            <a:ext cx="34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32"/>
          <p:cNvGrpSpPr/>
          <p:nvPr/>
        </p:nvGrpSpPr>
        <p:grpSpPr>
          <a:xfrm>
            <a:off x="1428840" y="266760"/>
            <a:ext cx="4682520" cy="8818560"/>
            <a:chOff x="1428840" y="266760"/>
            <a:chExt cx="4682520" cy="8818560"/>
          </a:xfrm>
        </p:grpSpPr>
        <p:sp>
          <p:nvSpPr>
            <p:cNvPr id="44" name="AutoShape 2"/>
            <p:cNvSpPr/>
            <p:nvPr/>
          </p:nvSpPr>
          <p:spPr>
            <a:xfrm>
              <a:off x="4807800" y="1322280"/>
              <a:ext cx="63720" cy="671760"/>
            </a:xfrm>
            <a:custGeom>
              <a:avLst/>
              <a:gdLst>
                <a:gd name="textAreaLeft" fmla="*/ 0 w 63720"/>
                <a:gd name="textAreaRight" fmla="*/ 44640 w 63720"/>
                <a:gd name="textAreaTop" fmla="*/ 27720 h 671760"/>
                <a:gd name="textAreaBottom" fmla="*/ 644040 h 6717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AutoShape 3"/>
            <p:cNvSpPr/>
            <p:nvPr/>
          </p:nvSpPr>
          <p:spPr>
            <a:xfrm>
              <a:off x="4807800" y="266760"/>
              <a:ext cx="63720" cy="922320"/>
            </a:xfrm>
            <a:custGeom>
              <a:avLst/>
              <a:gdLst>
                <a:gd name="textAreaLeft" fmla="*/ 0 w 63720"/>
                <a:gd name="textAreaRight" fmla="*/ 44640 w 63720"/>
                <a:gd name="textAreaTop" fmla="*/ 38160 h 922320"/>
                <a:gd name="textAreaBottom" fmla="*/ 884160 h 922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AutoShape 4"/>
            <p:cNvSpPr/>
            <p:nvPr/>
          </p:nvSpPr>
          <p:spPr>
            <a:xfrm>
              <a:off x="4809600" y="2570040"/>
              <a:ext cx="62280" cy="289080"/>
            </a:xfrm>
            <a:custGeom>
              <a:avLst/>
              <a:gdLst>
                <a:gd name="textAreaLeft" fmla="*/ 0 w 62280"/>
                <a:gd name="textAreaRight" fmla="*/ 43920 w 62280"/>
                <a:gd name="textAreaTop" fmla="*/ 11880 h 289080"/>
                <a:gd name="textAreaBottom" fmla="*/ 277200 h 2890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AutoShape 5"/>
            <p:cNvSpPr/>
            <p:nvPr/>
          </p:nvSpPr>
          <p:spPr>
            <a:xfrm>
              <a:off x="4809600" y="2090880"/>
              <a:ext cx="62280" cy="382320"/>
            </a:xfrm>
            <a:custGeom>
              <a:avLst/>
              <a:gdLst>
                <a:gd name="textAreaLeft" fmla="*/ 0 w 62280"/>
                <a:gd name="textAreaRight" fmla="*/ 43920 w 62280"/>
                <a:gd name="textAreaTop" fmla="*/ 15840 h 382320"/>
                <a:gd name="textAreaBottom" fmla="*/ 366480 h 382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8"/>
            <p:cNvSpPr/>
            <p:nvPr/>
          </p:nvSpPr>
          <p:spPr>
            <a:xfrm>
              <a:off x="4995360" y="582480"/>
              <a:ext cx="109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ibrio core grou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9"/>
            <p:cNvSpPr/>
            <p:nvPr/>
          </p:nvSpPr>
          <p:spPr>
            <a:xfrm>
              <a:off x="4986360" y="1428840"/>
              <a:ext cx="810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cholerae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mimic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0"/>
            <p:cNvSpPr/>
            <p:nvPr/>
          </p:nvSpPr>
          <p:spPr>
            <a:xfrm>
              <a:off x="4987080" y="213192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Aliivibri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1"/>
            <p:cNvSpPr/>
            <p:nvPr/>
          </p:nvSpPr>
          <p:spPr>
            <a:xfrm>
              <a:off x="5017680" y="2560680"/>
              <a:ext cx="98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Photobacter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AutoShape 12"/>
            <p:cNvSpPr/>
            <p:nvPr/>
          </p:nvSpPr>
          <p:spPr>
            <a:xfrm>
              <a:off x="4824360" y="3360600"/>
              <a:ext cx="63720" cy="922320"/>
            </a:xfrm>
            <a:custGeom>
              <a:avLst/>
              <a:gdLst>
                <a:gd name="textAreaLeft" fmla="*/ 0 w 63720"/>
                <a:gd name="textAreaRight" fmla="*/ 44640 w 63720"/>
                <a:gd name="textAreaTop" fmla="*/ 38160 h 922320"/>
                <a:gd name="textAreaBottom" fmla="*/ 884160 h 922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AutoShape 13"/>
            <p:cNvSpPr/>
            <p:nvPr/>
          </p:nvSpPr>
          <p:spPr>
            <a:xfrm>
              <a:off x="4826520" y="4390920"/>
              <a:ext cx="63720" cy="576360"/>
            </a:xfrm>
            <a:custGeom>
              <a:avLst/>
              <a:gdLst>
                <a:gd name="textAreaLeft" fmla="*/ 0 w 63720"/>
                <a:gd name="textAreaRight" fmla="*/ 44640 w 63720"/>
                <a:gd name="textAreaTop" fmla="*/ 23760 h 576360"/>
                <a:gd name="textAreaBottom" fmla="*/ 552600 h 576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AutoShape 14"/>
            <p:cNvSpPr/>
            <p:nvPr/>
          </p:nvSpPr>
          <p:spPr>
            <a:xfrm>
              <a:off x="4826520" y="5051520"/>
              <a:ext cx="63720" cy="384120"/>
            </a:xfrm>
            <a:custGeom>
              <a:avLst/>
              <a:gdLst>
                <a:gd name="textAreaLeft" fmla="*/ 0 w 63720"/>
                <a:gd name="textAreaRight" fmla="*/ 44640 w 63720"/>
                <a:gd name="textAreaTop" fmla="*/ 15840 h 384120"/>
                <a:gd name="textAreaBottom" fmla="*/ 368280 h 3841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AutoShape 15"/>
            <p:cNvSpPr/>
            <p:nvPr/>
          </p:nvSpPr>
          <p:spPr>
            <a:xfrm>
              <a:off x="4824360" y="5532480"/>
              <a:ext cx="63720" cy="287280"/>
            </a:xfrm>
            <a:custGeom>
              <a:avLst/>
              <a:gdLst>
                <a:gd name="textAreaLeft" fmla="*/ 0 w 63720"/>
                <a:gd name="textAreaRight" fmla="*/ 44640 w 63720"/>
                <a:gd name="textAreaTop" fmla="*/ 11880 h 287280"/>
                <a:gd name="textAreaBottom" fmla="*/ 275400 h 287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Picture 4" descr=""/>
            <p:cNvPicPr/>
            <p:nvPr/>
          </p:nvPicPr>
          <p:blipFill>
            <a:blip r:embed="rId2"/>
            <a:stretch/>
          </p:blipFill>
          <p:spPr>
            <a:xfrm>
              <a:off x="1428840" y="3227400"/>
              <a:ext cx="3461760" cy="2927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CaixaDeTexto 11"/>
            <p:cNvSpPr/>
            <p:nvPr/>
          </p:nvSpPr>
          <p:spPr>
            <a:xfrm>
              <a:off x="1906560" y="334656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B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8"/>
            <p:cNvSpPr/>
            <p:nvPr/>
          </p:nvSpPr>
          <p:spPr>
            <a:xfrm>
              <a:off x="5016240" y="3679920"/>
              <a:ext cx="109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ibrio core grou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19"/>
            <p:cNvSpPr/>
            <p:nvPr/>
          </p:nvSpPr>
          <p:spPr>
            <a:xfrm>
              <a:off x="4993200" y="509256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Aliivibri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0"/>
            <p:cNvSpPr/>
            <p:nvPr/>
          </p:nvSpPr>
          <p:spPr>
            <a:xfrm>
              <a:off x="4999680" y="4452840"/>
              <a:ext cx="810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cholerae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mimic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1"/>
            <p:cNvSpPr/>
            <p:nvPr/>
          </p:nvSpPr>
          <p:spPr>
            <a:xfrm>
              <a:off x="5004360" y="5554800"/>
              <a:ext cx="98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Photobacter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AutoShape 22"/>
            <p:cNvSpPr/>
            <p:nvPr/>
          </p:nvSpPr>
          <p:spPr>
            <a:xfrm>
              <a:off x="4824360" y="6311880"/>
              <a:ext cx="63720" cy="924120"/>
            </a:xfrm>
            <a:custGeom>
              <a:avLst/>
              <a:gdLst>
                <a:gd name="textAreaLeft" fmla="*/ 0 w 63720"/>
                <a:gd name="textAreaRight" fmla="*/ 44640 w 63720"/>
                <a:gd name="textAreaTop" fmla="*/ 38520 h 924120"/>
                <a:gd name="textAreaBottom" fmla="*/ 885960 h 9241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AutoShape 23"/>
            <p:cNvSpPr/>
            <p:nvPr/>
          </p:nvSpPr>
          <p:spPr>
            <a:xfrm>
              <a:off x="4824360" y="7358040"/>
              <a:ext cx="63720" cy="576360"/>
            </a:xfrm>
            <a:custGeom>
              <a:avLst/>
              <a:gdLst>
                <a:gd name="textAreaLeft" fmla="*/ 0 w 63720"/>
                <a:gd name="textAreaRight" fmla="*/ 44640 w 63720"/>
                <a:gd name="textAreaTop" fmla="*/ 23760 h 576360"/>
                <a:gd name="textAreaBottom" fmla="*/ 552600 h 576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AutoShape 24"/>
            <p:cNvSpPr/>
            <p:nvPr/>
          </p:nvSpPr>
          <p:spPr>
            <a:xfrm>
              <a:off x="4824360" y="8029440"/>
              <a:ext cx="63720" cy="382680"/>
            </a:xfrm>
            <a:custGeom>
              <a:avLst/>
              <a:gdLst>
                <a:gd name="textAreaLeft" fmla="*/ 0 w 63720"/>
                <a:gd name="textAreaRight" fmla="*/ 44640 w 63720"/>
                <a:gd name="textAreaTop" fmla="*/ 15840 h 382680"/>
                <a:gd name="textAreaBottom" fmla="*/ 366840 h 3826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AutoShape 25"/>
            <p:cNvSpPr/>
            <p:nvPr/>
          </p:nvSpPr>
          <p:spPr>
            <a:xfrm>
              <a:off x="4824360" y="8462880"/>
              <a:ext cx="63720" cy="287280"/>
            </a:xfrm>
            <a:custGeom>
              <a:avLst/>
              <a:gdLst>
                <a:gd name="textAreaLeft" fmla="*/ 0 w 63720"/>
                <a:gd name="textAreaRight" fmla="*/ 44640 w 63720"/>
                <a:gd name="textAreaTop" fmla="*/ 11880 h 287280"/>
                <a:gd name="textAreaBottom" fmla="*/ 275400 h 287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6" name="Picture 5" descr=""/>
            <p:cNvPicPr/>
            <p:nvPr/>
          </p:nvPicPr>
          <p:blipFill>
            <a:blip r:embed="rId3"/>
            <a:stretch/>
          </p:blipFill>
          <p:spPr>
            <a:xfrm>
              <a:off x="1513080" y="6195960"/>
              <a:ext cx="3377160" cy="288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CaixaDeTexto 12"/>
            <p:cNvSpPr/>
            <p:nvPr/>
          </p:nvSpPr>
          <p:spPr>
            <a:xfrm>
              <a:off x="1907640" y="631836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B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28"/>
            <p:cNvSpPr/>
            <p:nvPr/>
          </p:nvSpPr>
          <p:spPr>
            <a:xfrm>
              <a:off x="4967280" y="6635880"/>
              <a:ext cx="109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ibrio core grou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29"/>
            <p:cNvSpPr/>
            <p:nvPr/>
          </p:nvSpPr>
          <p:spPr>
            <a:xfrm>
              <a:off x="4977720" y="8091360"/>
              <a:ext cx="68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Aliivibri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30"/>
            <p:cNvSpPr/>
            <p:nvPr/>
          </p:nvSpPr>
          <p:spPr>
            <a:xfrm>
              <a:off x="5022000" y="7453440"/>
              <a:ext cx="8100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cholerae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V. mimic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31"/>
            <p:cNvSpPr/>
            <p:nvPr/>
          </p:nvSpPr>
          <p:spPr>
            <a:xfrm>
              <a:off x="5017680" y="8459640"/>
              <a:ext cx="986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000" spc="-1" strike="noStrike">
                  <a:solidFill>
                    <a:srgbClr val="000000"/>
                  </a:solidFill>
                  <a:latin typeface="Times New Roman"/>
                </a:rPr>
                <a:t>Photobacter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06T18:21:55Z</dcterms:created>
  <dc:creator>N/A</dc:creator>
  <dc:description/>
  <dc:language>en-US</dc:language>
  <cp:lastModifiedBy>IOC</cp:lastModifiedBy>
  <dcterms:modified xsi:type="dcterms:W3CDTF">2009-07-15T18:11:00Z</dcterms:modified>
  <cp:revision>7</cp:revision>
  <dc:subject/>
  <dc:title>Slide 1</dc:title>
</cp:coreProperties>
</file>